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155E89-4968-4BDF-8541-2C0847E01EA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BA0B5D-E55A-4B59-B374-90347C8D522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DED345-1CBB-47F0-8FA4-B27F224275E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03DF6B-08E6-48ED-AD91-CC5EFC8060C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FF47C0-57C7-4D13-A5B0-1FF64CA5412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1FD650-4CE7-4E7B-AA88-356D481BFD3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B23213-3386-42E6-B4F9-97E5BCCDA2B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2CEDED-63FC-4759-A4BC-97E37085287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4A636F-E76A-414F-85D1-64977253007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A1911C-BB17-4B8F-B96B-2B1172B0D0B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2D1CDB-FAA8-40D6-AED9-FACE7533CA4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2A7AC0-A1F4-4043-9F6D-089F7C85C4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0375680-FA40-42CE-89D0-B305ED151E2E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矩形 3"/>
          <p:cNvSpPr/>
          <p:nvPr/>
        </p:nvSpPr>
        <p:spPr>
          <a:xfrm>
            <a:off x="468360" y="4653000"/>
            <a:ext cx="84247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Supplemental Figure 1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Flow cytometry fluorescence analysis of PI-stained leaf nuclei in suspension. A. ‘Huanghua’. B. ‘Huanghua’ selfed progeny No. 7. C. ‘Huanghua’ selfed progeny No. 9. D. ‘Huanghua’ selfed progeny No. 18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图片 4" descr="流失细胞仪检测（2017-4-10）"/>
          <p:cNvPicPr/>
          <p:nvPr/>
        </p:nvPicPr>
        <p:blipFill>
          <a:blip r:embed="rId1"/>
          <a:stretch/>
        </p:blipFill>
        <p:spPr>
          <a:xfrm>
            <a:off x="250920" y="2060640"/>
            <a:ext cx="8243640" cy="2181240"/>
          </a:xfrm>
          <a:prstGeom prst="rect">
            <a:avLst/>
          </a:prstGeom>
          <a:ln w="0">
            <a:noFill/>
          </a:ln>
        </p:spPr>
      </p:pic>
      <p:sp>
        <p:nvSpPr>
          <p:cNvPr id="43" name="矩形 4"/>
          <p:cNvSpPr/>
          <p:nvPr/>
        </p:nvSpPr>
        <p:spPr>
          <a:xfrm>
            <a:off x="451440" y="476280"/>
            <a:ext cx="2337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77e97"/>
                </a:solidFill>
                <a:latin typeface="Calibri"/>
              </a:rPr>
              <a:t>SUPPLEMENTAL DATA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4" name=""/>
          <p:cNvGraphicFramePr/>
          <p:nvPr/>
        </p:nvGraphicFramePr>
        <p:xfrm>
          <a:off x="1258920" y="1844640"/>
          <a:ext cx="7129440" cy="3782880"/>
        </p:xfrm>
        <a:graphic>
          <a:graphicData uri="http://schemas.openxmlformats.org/drawingml/2006/table">
            <a:tbl>
              <a:tblPr/>
              <a:tblGrid>
                <a:gridCol w="965160"/>
                <a:gridCol w="4292640"/>
                <a:gridCol w="1871640"/>
              </a:tblGrid>
              <a:tr h="757440"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ts val="1998"/>
                        </a:lnSpc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am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ts val="1998"/>
                        </a:lnSpc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quence (5</a:t>
                      </a:r>
                      <a:r>
                        <a:rPr b="1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’</a:t>
                      </a: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o3</a:t>
                      </a:r>
                      <a:r>
                        <a:rPr b="1" lang="zh-CN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’</a:t>
                      </a: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ts val="1998"/>
                        </a:lnSpc>
                        <a:spcAft>
                          <a:spcPts val="6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t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7764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F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TTACGCAGCAATATCAGC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shimizu et al. (1999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7800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(A/G)TTCGGCCAAATAAT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shimizu et al. (1999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7908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</a:t>
                      </a:r>
                      <a:r>
                        <a:rPr b="1" lang="en-US" sz="14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F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AAGACTACAGCCCTGAATTCTCA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esent study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7800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</a:t>
                      </a:r>
                      <a:r>
                        <a:rPr b="1" lang="en-US" sz="14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R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CAGAAGCCTACATGATCGG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esent study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7800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</a:t>
                      </a:r>
                      <a:r>
                        <a:rPr b="1" lang="en-US" sz="14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F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TTGTGGCCTTCAACCAAAGT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esent study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7764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</a:t>
                      </a:r>
                      <a:r>
                        <a:rPr b="1" lang="en-US" sz="14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R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AGTAATGCTTCTGGTTCGGC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esent study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7944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Actin-F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TCTTTCACCACAACTGCT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tin gene (AF386514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7764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Actin-R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GAGCTTCCA TTCCAATCATG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tin gene (AF386514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45" name="Rectangle 1"/>
          <p:cNvSpPr/>
          <p:nvPr/>
        </p:nvSpPr>
        <p:spPr>
          <a:xfrm>
            <a:off x="938160" y="1131120"/>
            <a:ext cx="77216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Supplemental Table 1    Sequences of oligonucleotide primers used in this study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矩形 6"/>
          <p:cNvSpPr/>
          <p:nvPr/>
        </p:nvSpPr>
        <p:spPr>
          <a:xfrm>
            <a:off x="451440" y="476280"/>
            <a:ext cx="2337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77e97"/>
                </a:solidFill>
                <a:latin typeface="Calibri"/>
              </a:rPr>
              <a:t>SUPPLEMENTAL DATA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468360" y="98064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Supplemental Table 2  The changes in expression levels of S-RNase and related proteins in the S</a:t>
            </a:r>
            <a:r>
              <a:rPr b="1" lang="en-US" sz="1600" spc="-1" strike="noStrike" baseline="-25000">
                <a:solidFill>
                  <a:srgbClr val="000000"/>
                </a:solidFill>
                <a:latin typeface="Calibri"/>
              </a:rPr>
              <a:t>1</a:t>
            </a: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S</a:t>
            </a:r>
            <a:r>
              <a:rPr b="1" lang="en-US" sz="1600" spc="-1" strike="noStrike" baseline="-25000">
                <a:solidFill>
                  <a:srgbClr val="000000"/>
                </a:solidFill>
                <a:latin typeface="Calibri"/>
              </a:rPr>
              <a:t>1</a:t>
            </a: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 relative to the parent S</a:t>
            </a:r>
            <a:r>
              <a:rPr b="1" lang="en-US" sz="1600" spc="-1" strike="noStrike" baseline="-25000">
                <a:solidFill>
                  <a:srgbClr val="000000"/>
                </a:solidFill>
                <a:latin typeface="Calibri"/>
              </a:rPr>
              <a:t>1</a:t>
            </a: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S</a:t>
            </a:r>
            <a:r>
              <a:rPr b="1" lang="en-US" sz="16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8" name=""/>
          <p:cNvGraphicFramePr/>
          <p:nvPr/>
        </p:nvGraphicFramePr>
        <p:xfrm>
          <a:off x="755640" y="2060640"/>
          <a:ext cx="7777080" cy="4032360"/>
        </p:xfrm>
        <a:graphic>
          <a:graphicData uri="http://schemas.openxmlformats.org/drawingml/2006/table">
            <a:tbl>
              <a:tblPr/>
              <a:tblGrid>
                <a:gridCol w="1092240"/>
                <a:gridCol w="2351160"/>
                <a:gridCol w="1455480"/>
                <a:gridCol w="1338480"/>
                <a:gridCol w="1539720"/>
              </a:tblGrid>
              <a:tr h="53820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i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otei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am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</a:t>
                      </a: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/S</a:t>
                      </a: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</a:t>
                      </a: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old chang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orrecte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old chang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egul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yp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6820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91085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1-RNas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2468326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41040182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own Regulate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6820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91086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2-RNas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78754665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30943210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/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7000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9431661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KP1-like_1B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73172476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1661858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/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6820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9432142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EDD8-dissociated_culli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67608880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12411420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/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6820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9432986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KP1-like_1A_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7196437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19653176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/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7000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9436309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ullin-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74384652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3677309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/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6820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9439613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KP1-like_1A_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89537149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48870948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/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6820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9438672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ullin-1-lik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75814204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6054187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/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7000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943941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-box/WD-repeat_TBL1XR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8961886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14421372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p Regulate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6820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9440848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ullin-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74163851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331019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/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6856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9441019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-box_PP2-B1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74440632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377038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/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6964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9444346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-box/LRR-repeat_1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7541141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5384478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/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6856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9442667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ullin-3A-lik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61310665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01939552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/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49" name="矩形 5"/>
          <p:cNvSpPr/>
          <p:nvPr/>
        </p:nvSpPr>
        <p:spPr>
          <a:xfrm>
            <a:off x="451440" y="476280"/>
            <a:ext cx="2337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77e97"/>
                </a:solidFill>
                <a:latin typeface="Calibri"/>
              </a:rPr>
              <a:t>SUPPLEMENTAL DATA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68360" y="98064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Supplemental Table 3  The changes in expression levels of S-RNase and related proteins in the S</a:t>
            </a:r>
            <a:r>
              <a:rPr b="1" lang="en-US" sz="16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S</a:t>
            </a:r>
            <a:r>
              <a:rPr b="1" lang="en-US" sz="16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relative to the parent S</a:t>
            </a:r>
            <a:r>
              <a:rPr b="1" lang="en-US" sz="1600" spc="-1" strike="noStrike" baseline="-25000">
                <a:solidFill>
                  <a:srgbClr val="000000"/>
                </a:solidFill>
                <a:latin typeface="Calibri"/>
              </a:rPr>
              <a:t>1</a:t>
            </a: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S</a:t>
            </a:r>
            <a:r>
              <a:rPr b="1" lang="en-US" sz="16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51" name=""/>
          <p:cNvGraphicFramePr/>
          <p:nvPr/>
        </p:nvGraphicFramePr>
        <p:xfrm>
          <a:off x="755640" y="2060640"/>
          <a:ext cx="7777080" cy="4032360"/>
        </p:xfrm>
        <a:graphic>
          <a:graphicData uri="http://schemas.openxmlformats.org/drawingml/2006/table">
            <a:tbl>
              <a:tblPr/>
              <a:tblGrid>
                <a:gridCol w="1092240"/>
                <a:gridCol w="2351160"/>
                <a:gridCol w="1455480"/>
                <a:gridCol w="1338480"/>
                <a:gridCol w="1539720"/>
              </a:tblGrid>
              <a:tr h="53820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i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otei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am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</a:t>
                      </a: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/S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old chang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orrecte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old chang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egul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yp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6820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91085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1-RNas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74450504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94906078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/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6820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91086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2-RNas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91068968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16090530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/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7000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9431661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KP1-like_1B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99105908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633565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/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6820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9432142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EDD8-dissociated_culli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13829916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4510514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/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6820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9432986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KP1-like_1A_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11639502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42312901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/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7000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9436309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ullin-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13951684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45260364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/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6820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9439613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KP1-like_1A_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14505315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45966108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/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6820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9438672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ullin-1-lik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1422090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45603550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/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7000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943941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-box/WD-repeat_TBL1XR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12431037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43321913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/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6820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9440848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ullin-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14460118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45908493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/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6856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9441019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-box_PP2-B1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6076493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60716513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p Regulate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6964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9444346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-box/LRR-repeat_1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9547289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65140924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p Regulate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6856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9442667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ullin-3A-lik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15204776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46857748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/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52" name="矩形 5"/>
          <p:cNvSpPr/>
          <p:nvPr/>
        </p:nvSpPr>
        <p:spPr>
          <a:xfrm>
            <a:off x="451440" y="476280"/>
            <a:ext cx="2337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77e97"/>
                </a:solidFill>
                <a:latin typeface="Calibri"/>
              </a:rPr>
              <a:t>SUPPLEMENTAL DATA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3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3-03-22T07:07:00Z</dcterms:created>
  <dc:creator>Administrator</dc:creator>
  <dc:description/>
  <dc:language>en-US</dc:language>
  <cp:lastModifiedBy>齐 永杰</cp:lastModifiedBy>
  <dcterms:modified xsi:type="dcterms:W3CDTF">2023-08-08T11:43:38Z</dcterms:modified>
  <cp:revision>25</cp:revision>
  <dc:subject/>
  <dc:title>PowerPoint 演示文稿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B14FEE9455CC406697670E7DDD957F22_12</vt:lpwstr>
  </property>
  <property fmtid="{D5CDD505-2E9C-101B-9397-08002B2CF9AE}" pid="3" name="KSOProductBuildVer">
    <vt:lpwstr>2052-11.1.0.14036</vt:lpwstr>
  </property>
</Properties>
</file>